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E18B72-4DB6-426F-BC46-C3D959606F6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07BA08-9972-41E5-9972-EE7AF92195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97C4E3-C335-4FC5-A4D9-F4D9FC8B2AE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273AC4-D680-4337-BE4F-0124C9DAF01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36BB93-0AFB-41A6-B89D-FE2F4FB10E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B12720-9926-4661-9A9F-86539860F3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60E783-4535-4772-B13D-517BD63DBA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BC7EB3-7DBE-4153-8F12-1196CB7805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3A27B0-4AB8-4BD9-998D-521F3200FA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117219-977A-4A63-97E7-42ED71EAB9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CCE928-E5C3-4D7C-83C6-FFC6E31CCF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53C592-E795-4F2A-BBA8-5F601EE200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40067F-2075-4C1F-A0E5-97CB7EECEE2D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2"/>
          <p:cNvSpPr/>
          <p:nvPr/>
        </p:nvSpPr>
        <p:spPr>
          <a:xfrm>
            <a:off x="5661000" y="1065240"/>
            <a:ext cx="1152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Calibri"/>
              </a:rPr>
              <a:t>EST number in placent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333360" y="1595520"/>
          <a:ext cx="2735280" cy="1514520"/>
        </p:xfrm>
        <a:graphic>
          <a:graphicData uri="http://schemas.openxmlformats.org/drawingml/2006/table">
            <a:tbl>
              <a:tblPr/>
              <a:tblGrid>
                <a:gridCol w="2087640"/>
                <a:gridCol w="647640"/>
              </a:tblGrid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tin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β-</a:t>
                      </a: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t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0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γ1-</a:t>
                      </a: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t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7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α2-</a:t>
                      </a: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t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7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γ2-</a:t>
                      </a: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t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α1-</a:t>
                      </a: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t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Rectangle 4"/>
          <p:cNvSpPr/>
          <p:nvPr/>
        </p:nvSpPr>
        <p:spPr>
          <a:xfrm>
            <a:off x="2133720" y="1065240"/>
            <a:ext cx="11509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Calibri"/>
              </a:rPr>
              <a:t>EST number in placent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4" name=""/>
          <p:cNvGraphicFramePr/>
          <p:nvPr/>
        </p:nvGraphicFramePr>
        <p:xfrm>
          <a:off x="333360" y="3368520"/>
          <a:ext cx="2735280" cy="2271960"/>
        </p:xfrm>
        <a:graphic>
          <a:graphicData uri="http://schemas.openxmlformats.org/drawingml/2006/table">
            <a:tbl>
              <a:tblPr/>
              <a:tblGrid>
                <a:gridCol w="2087640"/>
                <a:gridCol w="647640"/>
              </a:tblGrid>
              <a:tr h="2527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α</a:t>
                      </a: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 tubul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7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5" name=""/>
          <p:cNvGraphicFramePr/>
          <p:nvPr/>
        </p:nvGraphicFramePr>
        <p:xfrm>
          <a:off x="333360" y="5745240"/>
          <a:ext cx="2735280" cy="2019240"/>
        </p:xfrm>
        <a:graphic>
          <a:graphicData uri="http://schemas.openxmlformats.org/drawingml/2006/table">
            <a:tbl>
              <a:tblPr/>
              <a:tblGrid>
                <a:gridCol w="2143080"/>
                <a:gridCol w="592200"/>
              </a:tblGrid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β</a:t>
                      </a: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 tubul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7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6" name=""/>
          <p:cNvGraphicFramePr/>
          <p:nvPr/>
        </p:nvGraphicFramePr>
        <p:xfrm>
          <a:off x="333360" y="7942320"/>
          <a:ext cx="2735280" cy="757080"/>
        </p:xfrm>
        <a:graphic>
          <a:graphicData uri="http://schemas.openxmlformats.org/drawingml/2006/table">
            <a:tbl>
              <a:tblPr/>
              <a:tblGrid>
                <a:gridCol w="2087640"/>
                <a:gridCol w="647640"/>
              </a:tblGrid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γ</a:t>
                      </a: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 tubul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7" name=""/>
          <p:cNvGraphicFramePr/>
          <p:nvPr/>
        </p:nvGraphicFramePr>
        <p:xfrm>
          <a:off x="3789360" y="7942320"/>
          <a:ext cx="2735280" cy="1262160"/>
        </p:xfrm>
        <a:graphic>
          <a:graphicData uri="http://schemas.openxmlformats.org/drawingml/2006/table">
            <a:tbl>
              <a:tblPr/>
              <a:tblGrid>
                <a:gridCol w="2087640"/>
                <a:gridCol w="647640"/>
              </a:tblGrid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termediate filament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iment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6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zr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oes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7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lectin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8" name=""/>
          <p:cNvGraphicFramePr/>
          <p:nvPr/>
        </p:nvGraphicFramePr>
        <p:xfrm>
          <a:off x="3789360" y="1595520"/>
          <a:ext cx="2735280" cy="6035760"/>
        </p:xfrm>
        <a:graphic>
          <a:graphicData uri="http://schemas.openxmlformats.org/drawingml/2006/table">
            <a:tbl>
              <a:tblPr/>
              <a:tblGrid>
                <a:gridCol w="2087640"/>
                <a:gridCol w="647640"/>
              </a:tblGrid>
              <a:tr h="3744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Keratins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other Keratins  Scored 0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7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1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3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1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 (histone deacteylase inducible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7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60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7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9 (only EST score was in placenta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B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27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9" name="Rectangle 10"/>
          <p:cNvSpPr/>
          <p:nvPr/>
        </p:nvSpPr>
        <p:spPr>
          <a:xfrm>
            <a:off x="336960" y="1065240"/>
            <a:ext cx="651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Calibri"/>
              </a:rPr>
              <a:t>mR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1"/>
          <p:cNvSpPr/>
          <p:nvPr/>
        </p:nvSpPr>
        <p:spPr>
          <a:xfrm>
            <a:off x="3792960" y="1065240"/>
            <a:ext cx="651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Calibri"/>
              </a:rPr>
              <a:t>mR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3"/>
          <p:cNvSpPr/>
          <p:nvPr/>
        </p:nvSpPr>
        <p:spPr>
          <a:xfrm>
            <a:off x="549360" y="130320"/>
            <a:ext cx="55436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Supplementary file -1:  EST representation of cytoskeletal proteins in human placent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23T08:40:47Z</dcterms:created>
  <dc:creator>Administrator</dc:creator>
  <dc:description/>
  <dc:language>en-US</dc:language>
  <cp:lastModifiedBy>Sarah Coleman</cp:lastModifiedBy>
  <dcterms:modified xsi:type="dcterms:W3CDTF">2013-01-15T12:12:58Z</dcterms:modified>
  <cp:revision>15</cp:revision>
  <dc:subject/>
  <dc:title>Slide 1</dc:title>
</cp:coreProperties>
</file>